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10"/>
  </p:notesMasterIdLst>
  <p:sldIdLst>
    <p:sldId id="262" r:id="rId2"/>
    <p:sldId id="257" r:id="rId3"/>
    <p:sldId id="258" r:id="rId4"/>
    <p:sldId id="259" r:id="rId5"/>
    <p:sldId id="260" r:id="rId6"/>
    <p:sldId id="261" r:id="rId7"/>
    <p:sldId id="263" r:id="rId8"/>
    <p:sldId id="264" r:id="rId9"/>
  </p:sldIdLst>
  <p:sldSz cx="6400800" cy="8686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ollock, David (Campus)" initials="PD(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407"/>
    <p:restoredTop sz="92181"/>
  </p:normalViewPr>
  <p:slideViewPr>
    <p:cSldViewPr snapToGrid="0" snapToObjects="1">
      <p:cViewPr varScale="1">
        <p:scale>
          <a:sx n="161" d="100"/>
          <a:sy n="161" d="100"/>
        </p:scale>
        <p:origin x="113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8E4DD6-CF4A-0E4C-93AB-E07C2D2312C5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2350" y="1143000"/>
            <a:ext cx="2273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79330A-326F-6046-AF0A-D68B75ADA1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182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62096" rtl="0" eaLnBrk="1" latinLnBrk="0" hangingPunct="1">
      <a:defRPr sz="1131" kern="1200">
        <a:solidFill>
          <a:schemeClr val="tx1"/>
        </a:solidFill>
        <a:latin typeface="+mn-lt"/>
        <a:ea typeface="+mn-ea"/>
        <a:cs typeface="+mn-cs"/>
      </a:defRPr>
    </a:lvl1pPr>
    <a:lvl2pPr marL="431048" algn="l" defTabSz="862096" rtl="0" eaLnBrk="1" latinLnBrk="0" hangingPunct="1">
      <a:defRPr sz="1131" kern="1200">
        <a:solidFill>
          <a:schemeClr val="tx1"/>
        </a:solidFill>
        <a:latin typeface="+mn-lt"/>
        <a:ea typeface="+mn-ea"/>
        <a:cs typeface="+mn-cs"/>
      </a:defRPr>
    </a:lvl2pPr>
    <a:lvl3pPr marL="862096" algn="l" defTabSz="862096" rtl="0" eaLnBrk="1" latinLnBrk="0" hangingPunct="1">
      <a:defRPr sz="1131" kern="1200">
        <a:solidFill>
          <a:schemeClr val="tx1"/>
        </a:solidFill>
        <a:latin typeface="+mn-lt"/>
        <a:ea typeface="+mn-ea"/>
        <a:cs typeface="+mn-cs"/>
      </a:defRPr>
    </a:lvl3pPr>
    <a:lvl4pPr marL="1293144" algn="l" defTabSz="862096" rtl="0" eaLnBrk="1" latinLnBrk="0" hangingPunct="1">
      <a:defRPr sz="1131" kern="1200">
        <a:solidFill>
          <a:schemeClr val="tx1"/>
        </a:solidFill>
        <a:latin typeface="+mn-lt"/>
        <a:ea typeface="+mn-ea"/>
        <a:cs typeface="+mn-cs"/>
      </a:defRPr>
    </a:lvl4pPr>
    <a:lvl5pPr marL="1724193" algn="l" defTabSz="862096" rtl="0" eaLnBrk="1" latinLnBrk="0" hangingPunct="1">
      <a:defRPr sz="1131" kern="1200">
        <a:solidFill>
          <a:schemeClr val="tx1"/>
        </a:solidFill>
        <a:latin typeface="+mn-lt"/>
        <a:ea typeface="+mn-ea"/>
        <a:cs typeface="+mn-cs"/>
      </a:defRPr>
    </a:lvl5pPr>
    <a:lvl6pPr marL="2155241" algn="l" defTabSz="862096" rtl="0" eaLnBrk="1" latinLnBrk="0" hangingPunct="1">
      <a:defRPr sz="1131" kern="1200">
        <a:solidFill>
          <a:schemeClr val="tx1"/>
        </a:solidFill>
        <a:latin typeface="+mn-lt"/>
        <a:ea typeface="+mn-ea"/>
        <a:cs typeface="+mn-cs"/>
      </a:defRPr>
    </a:lvl6pPr>
    <a:lvl7pPr marL="2586289" algn="l" defTabSz="862096" rtl="0" eaLnBrk="1" latinLnBrk="0" hangingPunct="1">
      <a:defRPr sz="1131" kern="1200">
        <a:solidFill>
          <a:schemeClr val="tx1"/>
        </a:solidFill>
        <a:latin typeface="+mn-lt"/>
        <a:ea typeface="+mn-ea"/>
        <a:cs typeface="+mn-cs"/>
      </a:defRPr>
    </a:lvl7pPr>
    <a:lvl8pPr marL="3017337" algn="l" defTabSz="862096" rtl="0" eaLnBrk="1" latinLnBrk="0" hangingPunct="1">
      <a:defRPr sz="1131" kern="1200">
        <a:solidFill>
          <a:schemeClr val="tx1"/>
        </a:solidFill>
        <a:latin typeface="+mn-lt"/>
        <a:ea typeface="+mn-ea"/>
        <a:cs typeface="+mn-cs"/>
      </a:defRPr>
    </a:lvl8pPr>
    <a:lvl9pPr marL="3448385" algn="l" defTabSz="862096" rtl="0" eaLnBrk="1" latinLnBrk="0" hangingPunct="1">
      <a:defRPr sz="113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92350" y="1143000"/>
            <a:ext cx="22733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79330A-326F-6046-AF0A-D68B75ADA10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3410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421660"/>
            <a:ext cx="5440680" cy="3024293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562581"/>
            <a:ext cx="4800600" cy="2097299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387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144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62492"/>
            <a:ext cx="1380173" cy="736166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62492"/>
            <a:ext cx="4060508" cy="736166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250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156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165670"/>
            <a:ext cx="5520690" cy="3613467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813322"/>
            <a:ext cx="5520690" cy="1900237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7263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312458"/>
            <a:ext cx="2720340" cy="55116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312458"/>
            <a:ext cx="2720340" cy="55116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61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62494"/>
            <a:ext cx="5520690" cy="167904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129473"/>
            <a:ext cx="2707838" cy="1043622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173095"/>
            <a:ext cx="2707838" cy="46671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129473"/>
            <a:ext cx="2721174" cy="1043622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173095"/>
            <a:ext cx="2721174" cy="46671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828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457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432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79120"/>
            <a:ext cx="2064425" cy="202692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250740"/>
            <a:ext cx="3240405" cy="6173258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606040"/>
            <a:ext cx="2064425" cy="4828011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746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79120"/>
            <a:ext cx="2064425" cy="202692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250740"/>
            <a:ext cx="3240405" cy="6173258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606040"/>
            <a:ext cx="2064425" cy="4828011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463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62494"/>
            <a:ext cx="5520690" cy="16790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312458"/>
            <a:ext cx="5520690" cy="55116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8051378"/>
            <a:ext cx="144018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E88597-102B-674F-A953-4AEB4C0AF6BD}" type="datetimeFigureOut">
              <a:rPr lang="en-US" smtClean="0"/>
              <a:t>11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8051378"/>
            <a:ext cx="216027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8051378"/>
            <a:ext cx="144018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A84AE1-969F-324E-8BF3-B49EF26294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316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5" Type="http://schemas.openxmlformats.org/officeDocument/2006/relationships/image" Target="../media/image15.jpg"/><Relationship Id="rId4" Type="http://schemas.openxmlformats.org/officeDocument/2006/relationships/image" Target="../media/image14.jp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71501" y="1686262"/>
            <a:ext cx="5257800" cy="49198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07" b="1" dirty="0"/>
              <a:t>SUPPLEMENTAL DATA</a:t>
            </a:r>
          </a:p>
          <a:p>
            <a:endParaRPr lang="en-US" sz="1307" dirty="0"/>
          </a:p>
          <a:p>
            <a:endParaRPr lang="en-US" sz="1307" dirty="0"/>
          </a:p>
          <a:p>
            <a:endParaRPr lang="en-US" sz="1307"/>
          </a:p>
          <a:p>
            <a:endParaRPr lang="en-US" sz="1307" dirty="0"/>
          </a:p>
          <a:p>
            <a:pPr algn="ctr"/>
            <a:r>
              <a:rPr lang="en-US" sz="1307" dirty="0"/>
              <a:t>Timing of food intake controls the diurnal rhythm of blood pressure independent of Bmal1 in the mouse</a:t>
            </a:r>
          </a:p>
          <a:p>
            <a:pPr algn="ctr"/>
            <a:r>
              <a:rPr lang="en-US" sz="1307" dirty="0"/>
              <a:t> </a:t>
            </a:r>
          </a:p>
          <a:p>
            <a:pPr algn="ctr"/>
            <a:endParaRPr lang="en-US" sz="1307" dirty="0"/>
          </a:p>
          <a:p>
            <a:pPr algn="ctr"/>
            <a:endParaRPr lang="en-US" sz="1307" dirty="0"/>
          </a:p>
          <a:p>
            <a:pPr algn="ctr"/>
            <a:r>
              <a:rPr lang="en-US" sz="1307" dirty="0" err="1"/>
              <a:t>Dingguo</a:t>
            </a:r>
            <a:r>
              <a:rPr lang="en-US" sz="1307" dirty="0"/>
              <a:t> Zhang, </a:t>
            </a:r>
            <a:r>
              <a:rPr lang="en-US" sz="1307" baseline="30000" dirty="0"/>
              <a:t>1</a:t>
            </a:r>
            <a:r>
              <a:rPr lang="en-US" sz="1307" dirty="0"/>
              <a:t> Jackson C. Colson, </a:t>
            </a:r>
            <a:r>
              <a:rPr lang="en-US" sz="1307" baseline="30000" dirty="0"/>
              <a:t>1</a:t>
            </a:r>
            <a:r>
              <a:rPr lang="en-US" sz="1307" dirty="0"/>
              <a:t> </a:t>
            </a:r>
            <a:r>
              <a:rPr lang="en-US" sz="1307" dirty="0" err="1"/>
              <a:t>Chunhua</a:t>
            </a:r>
            <a:r>
              <a:rPr lang="en-US" sz="1307" dirty="0"/>
              <a:t> </a:t>
            </a:r>
            <a:r>
              <a:rPr lang="en-US" sz="1307" dirty="0" err="1"/>
              <a:t>Jin</a:t>
            </a:r>
            <a:r>
              <a:rPr lang="en-US" sz="1307" dirty="0"/>
              <a:t>, </a:t>
            </a:r>
            <a:r>
              <a:rPr lang="en-US" sz="1307" baseline="30000" dirty="0"/>
              <a:t>1</a:t>
            </a:r>
            <a:r>
              <a:rPr lang="en-US" sz="1307" dirty="0"/>
              <a:t> Bryan K. Becker, </a:t>
            </a:r>
            <a:r>
              <a:rPr lang="en-US" sz="1307" baseline="30000" dirty="0"/>
              <a:t>1</a:t>
            </a:r>
            <a:r>
              <a:rPr lang="en-US" sz="1307" dirty="0"/>
              <a:t> Megan K. Rhoads, </a:t>
            </a:r>
            <a:r>
              <a:rPr lang="en-US" sz="1307" baseline="30000" dirty="0"/>
              <a:t>1</a:t>
            </a:r>
            <a:r>
              <a:rPr lang="en-US" sz="1307" dirty="0"/>
              <a:t> </a:t>
            </a:r>
            <a:r>
              <a:rPr lang="en-US" sz="1307" dirty="0" err="1"/>
              <a:t>Paramita</a:t>
            </a:r>
            <a:r>
              <a:rPr lang="en-US" sz="1307" dirty="0"/>
              <a:t> </a:t>
            </a:r>
            <a:r>
              <a:rPr lang="en-US" sz="1307" dirty="0" err="1"/>
              <a:t>Pati</a:t>
            </a:r>
            <a:r>
              <a:rPr lang="en-US" sz="1307" dirty="0"/>
              <a:t>, </a:t>
            </a:r>
            <a:r>
              <a:rPr lang="en-US" sz="1307" baseline="30000" dirty="0"/>
              <a:t>1</a:t>
            </a:r>
            <a:r>
              <a:rPr lang="en-US" sz="1307" dirty="0"/>
              <a:t> Thomas H. </a:t>
            </a:r>
            <a:r>
              <a:rPr lang="en-US" sz="1307" dirty="0" err="1"/>
              <a:t>Neder</a:t>
            </a:r>
            <a:r>
              <a:rPr lang="en-US" sz="1307" dirty="0"/>
              <a:t>, </a:t>
            </a:r>
            <a:r>
              <a:rPr lang="en-US" sz="1307" baseline="30000" dirty="0"/>
              <a:t>1</a:t>
            </a:r>
            <a:r>
              <a:rPr lang="en-US" sz="1307" dirty="0"/>
              <a:t> </a:t>
            </a:r>
            <a:r>
              <a:rPr lang="en-US" sz="1307" dirty="0" err="1"/>
              <a:t>Mckenzi</a:t>
            </a:r>
            <a:r>
              <a:rPr lang="en-US" sz="1307" dirty="0"/>
              <a:t> A. King, </a:t>
            </a:r>
            <a:r>
              <a:rPr lang="en-US" sz="1307" baseline="30000" dirty="0"/>
              <a:t>1</a:t>
            </a:r>
            <a:r>
              <a:rPr lang="en-US" sz="1307" dirty="0"/>
              <a:t> Jennifer A. </a:t>
            </a:r>
            <a:r>
              <a:rPr lang="en-US" sz="1307" dirty="0" err="1"/>
              <a:t>Valcin</a:t>
            </a:r>
            <a:r>
              <a:rPr lang="en-US" sz="1307" dirty="0"/>
              <a:t>, </a:t>
            </a:r>
            <a:r>
              <a:rPr lang="en-US" sz="1307" baseline="30000" dirty="0"/>
              <a:t>2</a:t>
            </a:r>
            <a:r>
              <a:rPr lang="en-US" sz="1307" dirty="0"/>
              <a:t> </a:t>
            </a:r>
            <a:r>
              <a:rPr lang="en-US" sz="1307" dirty="0" err="1"/>
              <a:t>Binli</a:t>
            </a:r>
            <a:r>
              <a:rPr lang="en-US" sz="1307" dirty="0"/>
              <a:t> Tao, </a:t>
            </a:r>
            <a:r>
              <a:rPr lang="en-US" sz="1307" baseline="30000" dirty="0"/>
              <a:t>1</a:t>
            </a:r>
            <a:r>
              <a:rPr lang="en-US" sz="1307" dirty="0"/>
              <a:t> </a:t>
            </a:r>
            <a:r>
              <a:rPr lang="en-US" sz="1307" dirty="0" err="1"/>
              <a:t>Malgorzata</a:t>
            </a:r>
            <a:r>
              <a:rPr lang="en-US" sz="1307" dirty="0"/>
              <a:t> </a:t>
            </a:r>
            <a:r>
              <a:rPr lang="en-US" sz="1307" dirty="0" err="1"/>
              <a:t>Kasztan</a:t>
            </a:r>
            <a:r>
              <a:rPr lang="en-US" sz="1307" dirty="0"/>
              <a:t>, </a:t>
            </a:r>
            <a:r>
              <a:rPr lang="en-US" sz="1307" baseline="30000" dirty="0"/>
              <a:t>1</a:t>
            </a:r>
            <a:r>
              <a:rPr lang="en-US" sz="1307" dirty="0"/>
              <a:t> Jodi Paul,</a:t>
            </a:r>
            <a:r>
              <a:rPr lang="en-US" sz="1307" baseline="30000" dirty="0"/>
              <a:t> 3</a:t>
            </a:r>
            <a:r>
              <a:rPr lang="en-US" sz="1307" dirty="0"/>
              <a:t> Shannon M. Bailey, </a:t>
            </a:r>
            <a:r>
              <a:rPr lang="en-US" sz="1307" baseline="30000" dirty="0"/>
              <a:t>2</a:t>
            </a:r>
            <a:r>
              <a:rPr lang="en-US" sz="1307" dirty="0"/>
              <a:t> Jennifer S. Pollock, </a:t>
            </a:r>
            <a:r>
              <a:rPr lang="en-US" sz="1307" baseline="30000" dirty="0"/>
              <a:t>1</a:t>
            </a:r>
            <a:r>
              <a:rPr lang="en-US" sz="1307" dirty="0"/>
              <a:t> Karen L. Gamble, </a:t>
            </a:r>
            <a:r>
              <a:rPr lang="en-US" sz="1307" baseline="30000" dirty="0"/>
              <a:t>3</a:t>
            </a:r>
            <a:r>
              <a:rPr lang="en-US" sz="1307" dirty="0"/>
              <a:t> David M. Pollock</a:t>
            </a:r>
            <a:r>
              <a:rPr lang="en-US" sz="1307" baseline="30000" dirty="0"/>
              <a:t>1</a:t>
            </a:r>
          </a:p>
          <a:p>
            <a:pPr algn="ctr"/>
            <a:r>
              <a:rPr lang="en-US" sz="1307" dirty="0"/>
              <a:t> </a:t>
            </a:r>
          </a:p>
          <a:p>
            <a:pPr algn="ctr"/>
            <a:endParaRPr lang="en-US" sz="1307" dirty="0"/>
          </a:p>
          <a:p>
            <a:pPr algn="ctr"/>
            <a:endParaRPr lang="en-US" sz="1307" dirty="0"/>
          </a:p>
          <a:p>
            <a:pPr algn="ctr"/>
            <a:r>
              <a:rPr lang="en-US" sz="1307" baseline="30000" dirty="0"/>
              <a:t>1</a:t>
            </a:r>
            <a:r>
              <a:rPr lang="en-US" sz="1307" dirty="0"/>
              <a:t>Division of Nephrology, Department of Medicine</a:t>
            </a:r>
          </a:p>
          <a:p>
            <a:pPr algn="ctr"/>
            <a:r>
              <a:rPr lang="en-US" sz="1307" baseline="30000" dirty="0"/>
              <a:t>2</a:t>
            </a:r>
            <a:r>
              <a:rPr lang="en-US" sz="1307" dirty="0"/>
              <a:t>Division of Molecular and Cellular Pathology, Department of Pathology</a:t>
            </a:r>
          </a:p>
          <a:p>
            <a:pPr algn="ctr"/>
            <a:r>
              <a:rPr lang="en-US" sz="1307" baseline="30000" dirty="0"/>
              <a:t>3</a:t>
            </a:r>
            <a:r>
              <a:rPr lang="en-US" sz="1307" dirty="0"/>
              <a:t>Division of Behavioral Neurobiology, Department of Psychology </a:t>
            </a:r>
          </a:p>
          <a:p>
            <a:pPr algn="ctr"/>
            <a:r>
              <a:rPr lang="en-US" sz="1307" dirty="0"/>
              <a:t>University of Alabama at Birmingham, Birmingham, AL 35294</a:t>
            </a:r>
          </a:p>
          <a:p>
            <a:pPr algn="ctr"/>
            <a:r>
              <a:rPr lang="en-US" sz="1307" dirty="0"/>
              <a:t> </a:t>
            </a:r>
          </a:p>
          <a:p>
            <a:pPr algn="ctr"/>
            <a:r>
              <a:rPr lang="en-US" sz="1307" dirty="0"/>
              <a:t> </a:t>
            </a:r>
          </a:p>
          <a:p>
            <a:pPr algn="ctr"/>
            <a:r>
              <a:rPr lang="en-US" sz="1307" dirty="0"/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0251473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2AA7FC29-3031-CB4C-BA6D-4DA320C8F61D}"/>
              </a:ext>
            </a:extLst>
          </p:cNvPr>
          <p:cNvGrpSpPr/>
          <p:nvPr/>
        </p:nvGrpSpPr>
        <p:grpSpPr>
          <a:xfrm>
            <a:off x="1994104" y="636581"/>
            <a:ext cx="2697932" cy="6113159"/>
            <a:chOff x="1994104" y="636581"/>
            <a:chExt cx="2697932" cy="6113159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94104" y="636581"/>
              <a:ext cx="2697932" cy="1828800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79308" y="4920940"/>
              <a:ext cx="2598344" cy="182880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0B576EE-222C-9A4C-9904-265A6C512D5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94104" y="2778760"/>
              <a:ext cx="2674962" cy="1828800"/>
            </a:xfrm>
            <a:prstGeom prst="rect">
              <a:avLst/>
            </a:prstGeom>
          </p:spPr>
        </p:pic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9405B65C-83E6-2248-B833-47530B7FA82F}"/>
              </a:ext>
            </a:extLst>
          </p:cNvPr>
          <p:cNvSpPr txBox="1"/>
          <p:nvPr/>
        </p:nvSpPr>
        <p:spPr>
          <a:xfrm>
            <a:off x="355600" y="80430"/>
            <a:ext cx="2702245" cy="350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80"/>
              <a:t>Supplement Figure </a:t>
            </a:r>
            <a:r>
              <a:rPr lang="en-US" sz="1680" dirty="0"/>
              <a:t>1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0" y="6798933"/>
            <a:ext cx="6400800" cy="7815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93" dirty="0"/>
              <a:t>Supplement Figure 1: Additional summary of telemetry data from </a:t>
            </a:r>
            <a:r>
              <a:rPr lang="en-US" sz="1493" b="1" dirty="0"/>
              <a:t>WT</a:t>
            </a:r>
            <a:r>
              <a:rPr lang="en-US" sz="1493" dirty="0"/>
              <a:t> mice. Average 24-hr mean arterial pressure (A) heart rate (B) and locomotor activity (c). Student’s t-test was used in to compare groups.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836849" y="546467"/>
            <a:ext cx="314510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844865" y="2694489"/>
            <a:ext cx="306494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 flipH="1">
            <a:off x="1838418" y="4842512"/>
            <a:ext cx="312941" cy="362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56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910506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5C26A37-84EB-9845-B0FA-3856890E06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6189" y="642766"/>
            <a:ext cx="2505547" cy="179222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89878" y="421920"/>
            <a:ext cx="314510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67336" y="441253"/>
            <a:ext cx="306494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89878" y="2493927"/>
            <a:ext cx="304892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260022" y="2493927"/>
            <a:ext cx="322524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D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89878" y="4607074"/>
            <a:ext cx="295274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405B65C-83E6-2248-B833-47530B7FA82F}"/>
              </a:ext>
            </a:extLst>
          </p:cNvPr>
          <p:cNvSpPr txBox="1"/>
          <p:nvPr/>
        </p:nvSpPr>
        <p:spPr>
          <a:xfrm>
            <a:off x="355600" y="80430"/>
            <a:ext cx="2702245" cy="362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56" dirty="0"/>
              <a:t>Supplement Figure 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0" y="6798933"/>
            <a:ext cx="6400800" cy="1011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93" dirty="0"/>
              <a:t>Supplement Figure 2: Average 24-hr urine volume (A), sodium excretion (B), potassium excretion (C), ET-1 excretion (D), and aldosterone excretion (E) during the last 2 days during ad libitum feeding or reverse feeding in </a:t>
            </a:r>
            <a:r>
              <a:rPr lang="en-US" sz="1493" b="1" dirty="0"/>
              <a:t>WT</a:t>
            </a:r>
            <a:r>
              <a:rPr lang="en-US" sz="1493" dirty="0"/>
              <a:t> mice. Statistical comparisons were made using Student’s t-test. 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659" y="2850426"/>
            <a:ext cx="2442021" cy="170688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509" y="4884861"/>
            <a:ext cx="2518071" cy="170688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4517" y="622520"/>
            <a:ext cx="2559370" cy="1801368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570" y="2845808"/>
            <a:ext cx="2429452" cy="17099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6206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1571" y="720126"/>
            <a:ext cx="2660904" cy="1828242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4131" y="4861466"/>
            <a:ext cx="2598344" cy="18288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728531" y="643264"/>
            <a:ext cx="314510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736547" y="2721984"/>
            <a:ext cx="306494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738149" y="4800704"/>
            <a:ext cx="304892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405B65C-83E6-2248-B833-47530B7FA82F}"/>
              </a:ext>
            </a:extLst>
          </p:cNvPr>
          <p:cNvSpPr txBox="1"/>
          <p:nvPr/>
        </p:nvSpPr>
        <p:spPr>
          <a:xfrm>
            <a:off x="355600" y="80430"/>
            <a:ext cx="2702245" cy="362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56" dirty="0"/>
              <a:t>Supplement Figure 3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0" y="6798933"/>
            <a:ext cx="6400800" cy="7815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93" dirty="0"/>
              <a:t>Supplement Figure 3: Additional summary of telemetry data from </a:t>
            </a:r>
            <a:r>
              <a:rPr lang="en-US" sz="1493" b="1" dirty="0"/>
              <a:t>Bmal1KO</a:t>
            </a:r>
            <a:r>
              <a:rPr lang="en-US" sz="1493" dirty="0"/>
              <a:t> mice. Average 24-hr mean arterial pressure (A) heart rate (B) and locomotor activity (c). Student’s t-test was used in to compare groups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CCEF43C-CC05-EA40-AD34-2113AD2943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03283" y="2789070"/>
            <a:ext cx="2679192" cy="18316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4266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405B65C-83E6-2248-B833-47530B7FA82F}"/>
              </a:ext>
            </a:extLst>
          </p:cNvPr>
          <p:cNvSpPr txBox="1"/>
          <p:nvPr/>
        </p:nvSpPr>
        <p:spPr>
          <a:xfrm>
            <a:off x="355599" y="76200"/>
            <a:ext cx="2679701" cy="362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56" dirty="0"/>
              <a:t>Supplement Figure 4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0" y="6798933"/>
            <a:ext cx="6400800" cy="1011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93" dirty="0"/>
              <a:t>Supplement Figure 4: Average 24-hr urine volume (A), sodium excretion (B), potassium excretion (C), ET-1 excretion (D), and aldosterone excretion (E) during the last 2 days during </a:t>
            </a:r>
            <a:r>
              <a:rPr lang="en-US" sz="1493" i="1" dirty="0"/>
              <a:t>ad libitum </a:t>
            </a:r>
            <a:r>
              <a:rPr lang="en-US" sz="1493" dirty="0"/>
              <a:t>feeding or reverse feeding in </a:t>
            </a:r>
            <a:r>
              <a:rPr lang="en-US" sz="1493" b="1" dirty="0"/>
              <a:t>Bmal1KO </a:t>
            </a:r>
            <a:r>
              <a:rPr lang="en-US" sz="1493" dirty="0"/>
              <a:t>mice. Statistical comparisons were made using Student’s t-test.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8859" y="792082"/>
            <a:ext cx="2553078" cy="18288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243" y="4921245"/>
            <a:ext cx="2697933" cy="18288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9855" y="834437"/>
            <a:ext cx="2598344" cy="18288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652" y="2914103"/>
            <a:ext cx="2598344" cy="18288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04B3E17-5A82-6047-B651-97460A7CAB2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82546" y="2914103"/>
            <a:ext cx="2620370" cy="18288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527801" y="751359"/>
            <a:ext cx="306494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/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520487" y="2804033"/>
            <a:ext cx="322524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D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54243" y="718698"/>
            <a:ext cx="314510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54243" y="2816340"/>
            <a:ext cx="304892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54243" y="4840666"/>
            <a:ext cx="295274" cy="3625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56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2890000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405B65C-83E6-2248-B833-47530B7FA82F}"/>
              </a:ext>
            </a:extLst>
          </p:cNvPr>
          <p:cNvSpPr txBox="1"/>
          <p:nvPr/>
        </p:nvSpPr>
        <p:spPr>
          <a:xfrm>
            <a:off x="355600" y="77895"/>
            <a:ext cx="2374900" cy="362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56" dirty="0"/>
              <a:t>Supplement Figure 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0" y="7730750"/>
            <a:ext cx="6400800" cy="7815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93" dirty="0"/>
              <a:t>Supplement Figure 5: Plasma levels of sodium (A), potassium (B), and chloride </a:t>
            </a:r>
            <a:r>
              <a:rPr lang="de-DE" sz="1493" dirty="0"/>
              <a:t>(C) </a:t>
            </a:r>
            <a:r>
              <a:rPr lang="de-DE" sz="1493" dirty="0" err="1"/>
              <a:t>were</a:t>
            </a:r>
            <a:r>
              <a:rPr lang="de-DE" sz="1493" dirty="0"/>
              <a:t> </a:t>
            </a:r>
            <a:r>
              <a:rPr lang="de-DE" sz="1493" dirty="0" err="1"/>
              <a:t>measured</a:t>
            </a:r>
            <a:r>
              <a:rPr lang="de-DE" sz="1493" dirty="0"/>
              <a:t> </a:t>
            </a:r>
            <a:r>
              <a:rPr lang="de-DE" sz="1493" dirty="0" err="1"/>
              <a:t>with</a:t>
            </a:r>
            <a:r>
              <a:rPr lang="de-DE" sz="1493" dirty="0"/>
              <a:t> </a:t>
            </a:r>
            <a:r>
              <a:rPr lang="de-DE" sz="1493" dirty="0" err="1"/>
              <a:t>the</a:t>
            </a:r>
            <a:r>
              <a:rPr lang="de-DE" sz="1493" dirty="0"/>
              <a:t> i-</a:t>
            </a:r>
            <a:r>
              <a:rPr lang="de-DE" sz="1493" dirty="0" err="1"/>
              <a:t>Stat</a:t>
            </a:r>
            <a:r>
              <a:rPr lang="de-DE" sz="1493" dirty="0"/>
              <a:t> </a:t>
            </a:r>
            <a:r>
              <a:rPr lang="de-DE" sz="1493" dirty="0" err="1"/>
              <a:t>Alinity</a:t>
            </a:r>
            <a:r>
              <a:rPr lang="de-DE" sz="1493" dirty="0"/>
              <a:t> </a:t>
            </a:r>
            <a:r>
              <a:rPr lang="de-DE" sz="1493" dirty="0" err="1"/>
              <a:t>system</a:t>
            </a:r>
            <a:r>
              <a:rPr lang="de-DE" sz="1493" dirty="0"/>
              <a:t> in </a:t>
            </a:r>
            <a:r>
              <a:rPr lang="de-DE" sz="1493" b="1" dirty="0"/>
              <a:t>C57Bl/6J </a:t>
            </a:r>
            <a:r>
              <a:rPr lang="de-DE" sz="1493" dirty="0" err="1"/>
              <a:t>mice</a:t>
            </a:r>
            <a:r>
              <a:rPr lang="de-DE" sz="1493" dirty="0"/>
              <a:t>. Statistical </a:t>
            </a:r>
            <a:r>
              <a:rPr lang="de-DE" sz="1493" dirty="0" err="1"/>
              <a:t>analysis</a:t>
            </a:r>
            <a:r>
              <a:rPr lang="de-DE" sz="1493" dirty="0"/>
              <a:t> was </a:t>
            </a:r>
            <a:r>
              <a:rPr lang="de-DE" sz="1493" dirty="0" err="1"/>
              <a:t>by</a:t>
            </a:r>
            <a:r>
              <a:rPr lang="de-DE" sz="1493" dirty="0"/>
              <a:t> </a:t>
            </a:r>
            <a:r>
              <a:rPr lang="de-DE" sz="1493" dirty="0" err="1"/>
              <a:t>two-way</a:t>
            </a:r>
            <a:r>
              <a:rPr lang="de-DE" sz="1493" dirty="0"/>
              <a:t> ANOVA.  </a:t>
            </a:r>
            <a:endParaRPr lang="en-US" sz="1493" dirty="0"/>
          </a:p>
        </p:txBody>
      </p:sp>
      <p:pic>
        <p:nvPicPr>
          <p:cNvPr id="4" name="Picture 3" descr="Chart, line chart&#10;&#10;Description automatically generated">
            <a:extLst>
              <a:ext uri="{FF2B5EF4-FFF2-40B4-BE49-F238E27FC236}">
                <a16:creationId xmlns:a16="http://schemas.microsoft.com/office/drawing/2014/main" id="{87C38170-DE51-4849-81B8-C2D68DBCBF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6863" y="370840"/>
            <a:ext cx="5130800" cy="7429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90542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9405B65C-83E6-2248-B833-47530B7FA82F}"/>
              </a:ext>
            </a:extLst>
          </p:cNvPr>
          <p:cNvSpPr txBox="1"/>
          <p:nvPr/>
        </p:nvSpPr>
        <p:spPr>
          <a:xfrm>
            <a:off x="355600" y="77895"/>
            <a:ext cx="2374900" cy="362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56" dirty="0"/>
              <a:t>Supplement Figure 6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0" y="7858156"/>
            <a:ext cx="6400800" cy="780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90" dirty="0"/>
              <a:t>Supplement Figure 6: </a:t>
            </a:r>
            <a:r>
              <a:rPr lang="en-US" sz="1490" dirty="0">
                <a:ea typeface="Times New Roman" charset="0"/>
              </a:rPr>
              <a:t>Systolic and diastolic blood pressure (SBP, DBP) of </a:t>
            </a:r>
            <a:r>
              <a:rPr lang="en-US" sz="1490" b="1" dirty="0">
                <a:ea typeface="Times New Roman" charset="0"/>
              </a:rPr>
              <a:t>WT</a:t>
            </a:r>
            <a:r>
              <a:rPr lang="en-US" sz="1490" dirty="0">
                <a:ea typeface="Times New Roman" charset="0"/>
              </a:rPr>
              <a:t> (A and B), </a:t>
            </a:r>
            <a:r>
              <a:rPr lang="en-US" sz="1490" b="1" dirty="0">
                <a:ea typeface="Times New Roman" charset="0"/>
              </a:rPr>
              <a:t>Bmal1KO</a:t>
            </a:r>
            <a:r>
              <a:rPr lang="en-US" sz="1490" dirty="0">
                <a:ea typeface="Times New Roman" charset="0"/>
              </a:rPr>
              <a:t> (C and D) mice under 12 h light/12 h dark </a:t>
            </a:r>
            <a:r>
              <a:rPr lang="en-US" sz="1490" dirty="0"/>
              <a:t>conditions during ad libitum feeding or reverse feeding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01595C2-2E23-C745-8F35-038B01A4B4D9}"/>
              </a:ext>
            </a:extLst>
          </p:cNvPr>
          <p:cNvSpPr txBox="1"/>
          <p:nvPr/>
        </p:nvSpPr>
        <p:spPr>
          <a:xfrm>
            <a:off x="5339296" y="2289438"/>
            <a:ext cx="346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wt</a:t>
            </a:r>
            <a:endParaRPr 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855E815-967A-8047-981C-6B2D6C14C420}"/>
              </a:ext>
            </a:extLst>
          </p:cNvPr>
          <p:cNvSpPr txBox="1"/>
          <p:nvPr/>
        </p:nvSpPr>
        <p:spPr>
          <a:xfrm>
            <a:off x="5339296" y="5871644"/>
            <a:ext cx="7897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mal1 KO</a:t>
            </a:r>
          </a:p>
        </p:txBody>
      </p:sp>
      <p:pic>
        <p:nvPicPr>
          <p:cNvPr id="5" name="Picture 4" descr="A picture containing diagram, schematic&#10;&#10;Description automatically generated">
            <a:extLst>
              <a:ext uri="{FF2B5EF4-FFF2-40B4-BE49-F238E27FC236}">
                <a16:creationId xmlns:a16="http://schemas.microsoft.com/office/drawing/2014/main" id="{3A5FACD2-E677-0543-A20D-EC5098A848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2825" y="544945"/>
            <a:ext cx="4170562" cy="7412182"/>
          </a:xfrm>
          <a:prstGeom prst="rect">
            <a:avLst/>
          </a:prstGeom>
        </p:spPr>
      </p:pic>
      <p:sp>
        <p:nvSpPr>
          <p:cNvPr id="7" name="Right Bracket 6">
            <a:extLst>
              <a:ext uri="{FF2B5EF4-FFF2-40B4-BE49-F238E27FC236}">
                <a16:creationId xmlns:a16="http://schemas.microsoft.com/office/drawing/2014/main" id="{E5F46DA3-7999-FE40-AFF1-617C7D1C5416}"/>
              </a:ext>
            </a:extLst>
          </p:cNvPr>
          <p:cNvSpPr/>
          <p:nvPr/>
        </p:nvSpPr>
        <p:spPr>
          <a:xfrm>
            <a:off x="5113387" y="779228"/>
            <a:ext cx="90095" cy="3228229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Bracket 14">
            <a:extLst>
              <a:ext uri="{FF2B5EF4-FFF2-40B4-BE49-F238E27FC236}">
                <a16:creationId xmlns:a16="http://schemas.microsoft.com/office/drawing/2014/main" id="{1663A826-B575-154A-9C59-7DF448436B2F}"/>
              </a:ext>
            </a:extLst>
          </p:cNvPr>
          <p:cNvSpPr/>
          <p:nvPr/>
        </p:nvSpPr>
        <p:spPr>
          <a:xfrm>
            <a:off x="5113387" y="4396028"/>
            <a:ext cx="90095" cy="3228229"/>
          </a:xfrm>
          <a:prstGeom prst="righ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0363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9405B65C-83E6-2248-B833-47530B7FA82F}"/>
              </a:ext>
            </a:extLst>
          </p:cNvPr>
          <p:cNvSpPr txBox="1"/>
          <p:nvPr/>
        </p:nvSpPr>
        <p:spPr>
          <a:xfrm>
            <a:off x="355600" y="77895"/>
            <a:ext cx="2374900" cy="362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56" dirty="0"/>
              <a:t>Supplement Figure 7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0" y="6766684"/>
            <a:ext cx="6400800" cy="1974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90" dirty="0"/>
              <a:t>Supplement Figure 7: </a:t>
            </a:r>
            <a:r>
              <a:rPr lang="en-US" sz="1490" dirty="0">
                <a:ea typeface="Times New Roman" charset="0"/>
              </a:rPr>
              <a:t>Continuous measures </a:t>
            </a:r>
            <a:r>
              <a:rPr lang="en-US" sz="1490" dirty="0"/>
              <a:t>of SBP, DBP, HR and locomotor activity of </a:t>
            </a:r>
            <a:r>
              <a:rPr lang="en-US" sz="1490" b="1" dirty="0"/>
              <a:t>C57BL/6J </a:t>
            </a:r>
            <a:r>
              <a:rPr lang="en-US" sz="1490" dirty="0"/>
              <a:t>mice in constant dark conditions are shown (A, B, C and D, respectively) during </a:t>
            </a:r>
            <a:r>
              <a:rPr lang="en-US" sz="1490" i="1" dirty="0"/>
              <a:t>ad libitum </a:t>
            </a:r>
            <a:r>
              <a:rPr lang="en-US" sz="1490" dirty="0"/>
              <a:t>feeding, reverse clock time feeding (7 am – 7 pm), or offset restricted feeding (1pm - 1 am).  Panels D and E show MAP and HR re-plotted for food restricted groups in reference to the time of food availability. Finally, Panel F shows feed anticipatory activity in the groups with reverse or offset feeding protocols showing a significant difference using an unpaired t-test (t(8) = 4.849, p = 0.0013).</a:t>
            </a:r>
          </a:p>
        </p:txBody>
      </p:sp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829A4BB9-C779-E648-B2E7-DABEE02CF0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6392" y="440430"/>
            <a:ext cx="5588015" cy="64037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80555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6</TotalTime>
  <Words>583</Words>
  <Application>Microsoft Macintosh PowerPoint</Application>
  <PresentationFormat>Custom</PresentationFormat>
  <Paragraphs>53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Dingguo</dc:creator>
  <cp:lastModifiedBy>Pollock, David (Campus)</cp:lastModifiedBy>
  <cp:revision>54</cp:revision>
  <cp:lastPrinted>2020-11-16T18:48:47Z</cp:lastPrinted>
  <dcterms:created xsi:type="dcterms:W3CDTF">2020-05-06T15:54:46Z</dcterms:created>
  <dcterms:modified xsi:type="dcterms:W3CDTF">2020-11-19T22:50:08Z</dcterms:modified>
</cp:coreProperties>
</file>